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94" r:id="rId2"/>
  </p:sldIdLst>
  <p:sldSz cx="12599988" cy="73802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1"/>
  </p:normalViewPr>
  <p:slideViewPr>
    <p:cSldViewPr snapToGrid="0">
      <p:cViewPr varScale="1">
        <p:scale>
          <a:sx n="100" d="100"/>
          <a:sy n="100" d="100"/>
        </p:scale>
        <p:origin x="10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9F633A-52CE-4205-9EC1-28817392FA88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95338" y="1143000"/>
            <a:ext cx="52673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9A0875-2DFE-4688-BEB6-50603822C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44365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74999" y="1207839"/>
            <a:ext cx="9449991" cy="2569434"/>
          </a:xfrm>
        </p:spPr>
        <p:txBody>
          <a:bodyPr anchor="b"/>
          <a:lstStyle>
            <a:lvl1pPr algn="ctr">
              <a:defRPr sz="620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3876360"/>
            <a:ext cx="9449991" cy="1781861"/>
          </a:xfrm>
        </p:spPr>
        <p:txBody>
          <a:bodyPr/>
          <a:lstStyle>
            <a:lvl1pPr marL="0" indent="0" algn="ctr">
              <a:buNone/>
              <a:defRPr sz="2480"/>
            </a:lvl1pPr>
            <a:lvl2pPr marL="472516" indent="0" algn="ctr">
              <a:buNone/>
              <a:defRPr sz="2067"/>
            </a:lvl2pPr>
            <a:lvl3pPr marL="945032" indent="0" algn="ctr">
              <a:buNone/>
              <a:defRPr sz="1860"/>
            </a:lvl3pPr>
            <a:lvl4pPr marL="1417549" indent="0" algn="ctr">
              <a:buNone/>
              <a:defRPr sz="1654"/>
            </a:lvl4pPr>
            <a:lvl5pPr marL="1890065" indent="0" algn="ctr">
              <a:buNone/>
              <a:defRPr sz="1654"/>
            </a:lvl5pPr>
            <a:lvl6pPr marL="2362581" indent="0" algn="ctr">
              <a:buNone/>
              <a:defRPr sz="1654"/>
            </a:lvl6pPr>
            <a:lvl7pPr marL="2835097" indent="0" algn="ctr">
              <a:buNone/>
              <a:defRPr sz="1654"/>
            </a:lvl7pPr>
            <a:lvl8pPr marL="3307613" indent="0" algn="ctr">
              <a:buNone/>
              <a:defRPr sz="1654"/>
            </a:lvl8pPr>
            <a:lvl9pPr marL="3780130" indent="0" algn="ctr">
              <a:buNone/>
              <a:defRPr sz="165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2865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4143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392932"/>
            <a:ext cx="2716872" cy="625445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49" y="392932"/>
            <a:ext cx="7993117" cy="625445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2091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9052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1839948"/>
            <a:ext cx="10867490" cy="3069994"/>
          </a:xfrm>
        </p:spPr>
        <p:txBody>
          <a:bodyPr anchor="b"/>
          <a:lstStyle>
            <a:lvl1pPr>
              <a:defRPr sz="620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4938986"/>
            <a:ext cx="10867490" cy="1614437"/>
          </a:xfrm>
        </p:spPr>
        <p:txBody>
          <a:bodyPr/>
          <a:lstStyle>
            <a:lvl1pPr marL="0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1pPr>
            <a:lvl2pPr marL="472516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2pPr>
            <a:lvl3pPr marL="945032" indent="0">
              <a:buNone/>
              <a:defRPr sz="1860">
                <a:solidFill>
                  <a:schemeClr val="tx1">
                    <a:tint val="75000"/>
                  </a:schemeClr>
                </a:solidFill>
              </a:defRPr>
            </a:lvl3pPr>
            <a:lvl4pPr marL="1417549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4pPr>
            <a:lvl5pPr marL="1890065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5pPr>
            <a:lvl6pPr marL="2362581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6pPr>
            <a:lvl7pPr marL="2835097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7pPr>
            <a:lvl8pPr marL="3307613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8pPr>
            <a:lvl9pPr marL="3780130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8925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1964660"/>
            <a:ext cx="5354995" cy="468272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1964660"/>
            <a:ext cx="5354995" cy="468272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376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392932"/>
            <a:ext cx="10867490" cy="142651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1" y="1809196"/>
            <a:ext cx="5330385" cy="886659"/>
          </a:xfrm>
        </p:spPr>
        <p:txBody>
          <a:bodyPr anchor="b"/>
          <a:lstStyle>
            <a:lvl1pPr marL="0" indent="0">
              <a:buNone/>
              <a:defRPr sz="2480" b="1"/>
            </a:lvl1pPr>
            <a:lvl2pPr marL="472516" indent="0">
              <a:buNone/>
              <a:defRPr sz="2067" b="1"/>
            </a:lvl2pPr>
            <a:lvl3pPr marL="945032" indent="0">
              <a:buNone/>
              <a:defRPr sz="1860" b="1"/>
            </a:lvl3pPr>
            <a:lvl4pPr marL="1417549" indent="0">
              <a:buNone/>
              <a:defRPr sz="1654" b="1"/>
            </a:lvl4pPr>
            <a:lvl5pPr marL="1890065" indent="0">
              <a:buNone/>
              <a:defRPr sz="1654" b="1"/>
            </a:lvl5pPr>
            <a:lvl6pPr marL="2362581" indent="0">
              <a:buNone/>
              <a:defRPr sz="1654" b="1"/>
            </a:lvl6pPr>
            <a:lvl7pPr marL="2835097" indent="0">
              <a:buNone/>
              <a:defRPr sz="1654" b="1"/>
            </a:lvl7pPr>
            <a:lvl8pPr marL="3307613" indent="0">
              <a:buNone/>
              <a:defRPr sz="1654" b="1"/>
            </a:lvl8pPr>
            <a:lvl9pPr marL="3780130" indent="0">
              <a:buNone/>
              <a:defRPr sz="165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1" y="2695855"/>
            <a:ext cx="5330385" cy="396519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4" y="1809196"/>
            <a:ext cx="5356636" cy="886659"/>
          </a:xfrm>
        </p:spPr>
        <p:txBody>
          <a:bodyPr anchor="b"/>
          <a:lstStyle>
            <a:lvl1pPr marL="0" indent="0">
              <a:buNone/>
              <a:defRPr sz="2480" b="1"/>
            </a:lvl1pPr>
            <a:lvl2pPr marL="472516" indent="0">
              <a:buNone/>
              <a:defRPr sz="2067" b="1"/>
            </a:lvl2pPr>
            <a:lvl3pPr marL="945032" indent="0">
              <a:buNone/>
              <a:defRPr sz="1860" b="1"/>
            </a:lvl3pPr>
            <a:lvl4pPr marL="1417549" indent="0">
              <a:buNone/>
              <a:defRPr sz="1654" b="1"/>
            </a:lvl4pPr>
            <a:lvl5pPr marL="1890065" indent="0">
              <a:buNone/>
              <a:defRPr sz="1654" b="1"/>
            </a:lvl5pPr>
            <a:lvl6pPr marL="2362581" indent="0">
              <a:buNone/>
              <a:defRPr sz="1654" b="1"/>
            </a:lvl6pPr>
            <a:lvl7pPr marL="2835097" indent="0">
              <a:buNone/>
              <a:defRPr sz="1654" b="1"/>
            </a:lvl7pPr>
            <a:lvl8pPr marL="3307613" indent="0">
              <a:buNone/>
              <a:defRPr sz="1654" b="1"/>
            </a:lvl8pPr>
            <a:lvl9pPr marL="3780130" indent="0">
              <a:buNone/>
              <a:defRPr sz="165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4" y="2695855"/>
            <a:ext cx="5356636" cy="396519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3671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0714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9344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492019"/>
            <a:ext cx="4063824" cy="1722067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062625"/>
            <a:ext cx="6378744" cy="5244788"/>
          </a:xfrm>
        </p:spPr>
        <p:txBody>
          <a:bodyPr/>
          <a:lstStyle>
            <a:lvl1pPr>
              <a:defRPr sz="3307"/>
            </a:lvl1pPr>
            <a:lvl2pPr>
              <a:defRPr sz="2894"/>
            </a:lvl2pPr>
            <a:lvl3pPr>
              <a:defRPr sz="2480"/>
            </a:lvl3pPr>
            <a:lvl4pPr>
              <a:defRPr sz="2067"/>
            </a:lvl4pPr>
            <a:lvl5pPr>
              <a:defRPr sz="2067"/>
            </a:lvl5pPr>
            <a:lvl6pPr>
              <a:defRPr sz="2067"/>
            </a:lvl6pPr>
            <a:lvl7pPr>
              <a:defRPr sz="2067"/>
            </a:lvl7pPr>
            <a:lvl8pPr>
              <a:defRPr sz="2067"/>
            </a:lvl8pPr>
            <a:lvl9pPr>
              <a:defRPr sz="20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2214086"/>
            <a:ext cx="4063824" cy="4101869"/>
          </a:xfrm>
        </p:spPr>
        <p:txBody>
          <a:bodyPr/>
          <a:lstStyle>
            <a:lvl1pPr marL="0" indent="0">
              <a:buNone/>
              <a:defRPr sz="1654"/>
            </a:lvl1pPr>
            <a:lvl2pPr marL="472516" indent="0">
              <a:buNone/>
              <a:defRPr sz="1447"/>
            </a:lvl2pPr>
            <a:lvl3pPr marL="945032" indent="0">
              <a:buNone/>
              <a:defRPr sz="1240"/>
            </a:lvl3pPr>
            <a:lvl4pPr marL="1417549" indent="0">
              <a:buNone/>
              <a:defRPr sz="1034"/>
            </a:lvl4pPr>
            <a:lvl5pPr marL="1890065" indent="0">
              <a:buNone/>
              <a:defRPr sz="1034"/>
            </a:lvl5pPr>
            <a:lvl6pPr marL="2362581" indent="0">
              <a:buNone/>
              <a:defRPr sz="1034"/>
            </a:lvl6pPr>
            <a:lvl7pPr marL="2835097" indent="0">
              <a:buNone/>
              <a:defRPr sz="1034"/>
            </a:lvl7pPr>
            <a:lvl8pPr marL="3307613" indent="0">
              <a:buNone/>
              <a:defRPr sz="1034"/>
            </a:lvl8pPr>
            <a:lvl9pPr marL="3780130" indent="0">
              <a:buNone/>
              <a:defRPr sz="103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340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492019"/>
            <a:ext cx="4063824" cy="1722067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062625"/>
            <a:ext cx="6378744" cy="5244788"/>
          </a:xfrm>
        </p:spPr>
        <p:txBody>
          <a:bodyPr anchor="t"/>
          <a:lstStyle>
            <a:lvl1pPr marL="0" indent="0">
              <a:buNone/>
              <a:defRPr sz="3307"/>
            </a:lvl1pPr>
            <a:lvl2pPr marL="472516" indent="0">
              <a:buNone/>
              <a:defRPr sz="2894"/>
            </a:lvl2pPr>
            <a:lvl3pPr marL="945032" indent="0">
              <a:buNone/>
              <a:defRPr sz="2480"/>
            </a:lvl3pPr>
            <a:lvl4pPr marL="1417549" indent="0">
              <a:buNone/>
              <a:defRPr sz="2067"/>
            </a:lvl4pPr>
            <a:lvl5pPr marL="1890065" indent="0">
              <a:buNone/>
              <a:defRPr sz="2067"/>
            </a:lvl5pPr>
            <a:lvl6pPr marL="2362581" indent="0">
              <a:buNone/>
              <a:defRPr sz="2067"/>
            </a:lvl6pPr>
            <a:lvl7pPr marL="2835097" indent="0">
              <a:buNone/>
              <a:defRPr sz="2067"/>
            </a:lvl7pPr>
            <a:lvl8pPr marL="3307613" indent="0">
              <a:buNone/>
              <a:defRPr sz="2067"/>
            </a:lvl8pPr>
            <a:lvl9pPr marL="3780130" indent="0">
              <a:buNone/>
              <a:defRPr sz="20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2214086"/>
            <a:ext cx="4063824" cy="4101869"/>
          </a:xfrm>
        </p:spPr>
        <p:txBody>
          <a:bodyPr/>
          <a:lstStyle>
            <a:lvl1pPr marL="0" indent="0">
              <a:buNone/>
              <a:defRPr sz="1654"/>
            </a:lvl1pPr>
            <a:lvl2pPr marL="472516" indent="0">
              <a:buNone/>
              <a:defRPr sz="1447"/>
            </a:lvl2pPr>
            <a:lvl3pPr marL="945032" indent="0">
              <a:buNone/>
              <a:defRPr sz="1240"/>
            </a:lvl3pPr>
            <a:lvl4pPr marL="1417549" indent="0">
              <a:buNone/>
              <a:defRPr sz="1034"/>
            </a:lvl4pPr>
            <a:lvl5pPr marL="1890065" indent="0">
              <a:buNone/>
              <a:defRPr sz="1034"/>
            </a:lvl5pPr>
            <a:lvl6pPr marL="2362581" indent="0">
              <a:buNone/>
              <a:defRPr sz="1034"/>
            </a:lvl6pPr>
            <a:lvl7pPr marL="2835097" indent="0">
              <a:buNone/>
              <a:defRPr sz="1034"/>
            </a:lvl7pPr>
            <a:lvl8pPr marL="3307613" indent="0">
              <a:buNone/>
              <a:defRPr sz="1034"/>
            </a:lvl8pPr>
            <a:lvl9pPr marL="3780130" indent="0">
              <a:buNone/>
              <a:defRPr sz="103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8824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392932"/>
            <a:ext cx="10867490" cy="14265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1964660"/>
            <a:ext cx="10867490" cy="46827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6840434"/>
            <a:ext cx="2834997" cy="39293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0D1557-51BB-48FF-BE4A-F8EDF71AA526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6840434"/>
            <a:ext cx="4252496" cy="39293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6840434"/>
            <a:ext cx="2834997" cy="39293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F687B-7633-4399-9B01-EA09E901BCD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5939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45032" rtl="0" eaLnBrk="1" latinLnBrk="0" hangingPunct="1">
        <a:lnSpc>
          <a:spcPct val="90000"/>
        </a:lnSpc>
        <a:spcBef>
          <a:spcPct val="0"/>
        </a:spcBef>
        <a:buNone/>
        <a:defRPr sz="45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6258" indent="-236258" algn="l" defTabSz="945032" rtl="0" eaLnBrk="1" latinLnBrk="0" hangingPunct="1">
        <a:lnSpc>
          <a:spcPct val="90000"/>
        </a:lnSpc>
        <a:spcBef>
          <a:spcPts val="1034"/>
        </a:spcBef>
        <a:buFont typeface="Arial" panose="020B0604020202020204" pitchFamily="34" charset="0"/>
        <a:buChar char="•"/>
        <a:defRPr sz="2894" kern="1200">
          <a:solidFill>
            <a:schemeClr val="tx1"/>
          </a:solidFill>
          <a:latin typeface="+mn-lt"/>
          <a:ea typeface="+mn-ea"/>
          <a:cs typeface="+mn-cs"/>
        </a:defRPr>
      </a:lvl1pPr>
      <a:lvl2pPr marL="708774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181291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2067" kern="1200">
          <a:solidFill>
            <a:schemeClr val="tx1"/>
          </a:solidFill>
          <a:latin typeface="+mn-lt"/>
          <a:ea typeface="+mn-ea"/>
          <a:cs typeface="+mn-cs"/>
        </a:defRPr>
      </a:lvl3pPr>
      <a:lvl4pPr marL="1653807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4pPr>
      <a:lvl5pPr marL="2126323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5pPr>
      <a:lvl6pPr marL="2598839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6pPr>
      <a:lvl7pPr marL="3071355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7pPr>
      <a:lvl8pPr marL="3543872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8pPr>
      <a:lvl9pPr marL="4016388" indent="-236258" algn="l" defTabSz="94503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1pPr>
      <a:lvl2pPr marL="472516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2pPr>
      <a:lvl3pPr marL="945032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3pPr>
      <a:lvl4pPr marL="1417549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4pPr>
      <a:lvl5pPr marL="1890065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5pPr>
      <a:lvl6pPr marL="2362581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6pPr>
      <a:lvl7pPr marL="2835097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7pPr>
      <a:lvl8pPr marL="3307613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8pPr>
      <a:lvl9pPr marL="3780130" algn="l" defTabSz="945032" rtl="0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DE1D57F3-75D6-4976-9A4E-16B6CE7BAE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93374" y="794819"/>
            <a:ext cx="5440680" cy="544068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1EB3E90-2341-4037-A9ED-086ED73BBD7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671221" y="794984"/>
            <a:ext cx="5440680" cy="5440680"/>
          </a:xfrm>
          <a:prstGeom prst="rect">
            <a:avLst/>
          </a:prstGeom>
        </p:spPr>
      </p:pic>
      <p:sp>
        <p:nvSpPr>
          <p:cNvPr id="5" name="TextBox 63">
            <a:extLst>
              <a:ext uri="{FF2B5EF4-FFF2-40B4-BE49-F238E27FC236}">
                <a16:creationId xmlns:a16="http://schemas.microsoft.com/office/drawing/2014/main" id="{0D1F5F96-D012-404A-A22C-876C1F53D11E}"/>
              </a:ext>
            </a:extLst>
          </p:cNvPr>
          <p:cNvSpPr txBox="1"/>
          <p:nvPr/>
        </p:nvSpPr>
        <p:spPr>
          <a:xfrm>
            <a:off x="608742" y="440307"/>
            <a:ext cx="39873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A</a:t>
            </a:r>
            <a:endParaRPr lang="zh-CN" altLang="en-US" sz="2800" b="1" dirty="0"/>
          </a:p>
        </p:txBody>
      </p:sp>
      <p:sp>
        <p:nvSpPr>
          <p:cNvPr id="8" name="TextBox 63">
            <a:extLst>
              <a:ext uri="{FF2B5EF4-FFF2-40B4-BE49-F238E27FC236}">
                <a16:creationId xmlns:a16="http://schemas.microsoft.com/office/drawing/2014/main" id="{4090B95F-8918-4DF0-8017-1D7A67C6014F}"/>
              </a:ext>
            </a:extLst>
          </p:cNvPr>
          <p:cNvSpPr txBox="1"/>
          <p:nvPr/>
        </p:nvSpPr>
        <p:spPr>
          <a:xfrm>
            <a:off x="6495746" y="446057"/>
            <a:ext cx="39873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B</a:t>
            </a:r>
            <a:endParaRPr lang="zh-CN" altLang="en-US" sz="2800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90AB1A3-D87D-4570-A72D-228D28B075BF}"/>
              </a:ext>
            </a:extLst>
          </p:cNvPr>
          <p:cNvSpPr txBox="1"/>
          <p:nvPr/>
        </p:nvSpPr>
        <p:spPr>
          <a:xfrm>
            <a:off x="793374" y="6218059"/>
            <a:ext cx="11379576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12. </a:t>
            </a:r>
            <a:r>
              <a:rPr lang="en-US" altLang="zh-CN" sz="16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istributions of association between significantly altered metabolites and bacterial species for </a:t>
            </a:r>
            <a:r>
              <a:rPr lang="en-US" altLang="zh-CN" sz="16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RC, CRA and NC groups</a:t>
            </a:r>
            <a:r>
              <a:rPr lang="en-US" altLang="zh-CN" sz="16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6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altLang="zh-CN" sz="16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umulative distribution for negative associations for </a:t>
            </a:r>
            <a:r>
              <a:rPr lang="en-US" altLang="zh-CN" sz="16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RC, CRA and NC groups</a:t>
            </a:r>
            <a:r>
              <a:rPr lang="en-US" altLang="zh-CN" sz="16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altLang="zh-CN" sz="16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</a:t>
            </a:r>
            <a:r>
              <a:rPr lang="en-US" altLang="zh-CN" sz="16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umulative distribution for positive associations for </a:t>
            </a:r>
            <a:r>
              <a:rPr lang="en-US" altLang="zh-CN" sz="16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RC, CRA and NC groups</a:t>
            </a:r>
            <a:r>
              <a:rPr lang="en-US" altLang="zh-CN" sz="1600" kern="1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HK" altLang="zh-CN" sz="1600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C; colorectal cancer, CRA; colorectal adenoma, NC; normal control.</a:t>
            </a:r>
            <a:endParaRPr lang="zh-CN" altLang="zh-CN" sz="1600" kern="1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8578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0</TotalTime>
  <Words>70</Words>
  <Application>Microsoft Office PowerPoint</Application>
  <PresentationFormat>自定义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an Liu</dc:creator>
  <cp:lastModifiedBy>Changan Liu</cp:lastModifiedBy>
  <cp:revision>67</cp:revision>
  <dcterms:created xsi:type="dcterms:W3CDTF">2020-05-22T02:50:14Z</dcterms:created>
  <dcterms:modified xsi:type="dcterms:W3CDTF">2021-10-21T03:57:03Z</dcterms:modified>
</cp:coreProperties>
</file>